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notesMasterIdLst>
    <p:notesMasterId r:id="rId3"/>
  </p:notesMasterIdLst>
  <p:handoutMasterIdLst>
    <p:handoutMasterId r:id="rId4"/>
  </p:handoutMasterIdLst>
  <p:sldIdLst>
    <p:sldId id="1830" r:id="rId2"/>
  </p:sldIdLst>
  <p:sldSz cx="12192000" cy="6858000"/>
  <p:notesSz cx="6735763" cy="9866313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Calibri" panose="020F0502020204030204" pitchFamily="34" charset="0"/>
        <a:ea typeface="ＭＳ Ｐゴシック" panose="020B0600070205080204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CC"/>
    <a:srgbClr val="FFCCFF"/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スタイル (中間)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E8034E78-7F5D-4C2E-B375-FC64B27BC917}" styleName="スタイル (濃色)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25E5076-3810-47DD-B79F-674D7AD40C01}" styleName="濃色スタイル 1 - アクセント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E8B1032C-EA38-4F05-BA0D-38AFFFC7BED3}" styleName="淡色スタイル 3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85BE263C-DBD7-4A20-BB59-AAB30ACAA65A}" styleName="中間スタイル 3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5DA37D80-6434-44D0-A028-1B22A696006F}" styleName="淡色スタイル 3 - アクセント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72833802-FEF1-4C79-8D5D-14CF1EAF98D9}" styleName="淡色スタイル 2 - アクセント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スタイル (淡色)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652" autoAdjust="0"/>
    <p:restoredTop sz="94694"/>
  </p:normalViewPr>
  <p:slideViewPr>
    <p:cSldViewPr snapToGrid="0">
      <p:cViewPr varScale="1">
        <p:scale>
          <a:sx n="82" d="100"/>
          <a:sy n="82" d="100"/>
        </p:scale>
        <p:origin x="720" y="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Q8'!$I$4</c:f>
              <c:strCache>
                <c:ptCount val="1"/>
                <c:pt idx="0">
                  <c:v>話し合ったことがある</c:v>
                </c:pt>
              </c:strCache>
            </c:strRef>
          </c:tx>
          <c:spPr>
            <a:solidFill>
              <a:schemeClr val="accent6"/>
            </a:solidFill>
            <a:ln>
              <a:solidFill>
                <a:schemeClr val="accent5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5"/>
              </a:solidFill>
              <a:ln>
                <a:solidFill>
                  <a:schemeClr val="accent5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0-96D2-4B05-A0EB-ABBA9BB9860B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5"/>
              </a:solidFill>
              <a:ln>
                <a:solidFill>
                  <a:schemeClr val="accent5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6D2-4B05-A0EB-ABBA9BB9860B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5"/>
              </a:solidFill>
              <a:ln>
                <a:solidFill>
                  <a:schemeClr val="accent5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96D2-4B05-A0EB-ABBA9BB9860B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/>
              </a:solidFill>
              <a:ln>
                <a:solidFill>
                  <a:schemeClr val="accent5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6D2-4B05-A0EB-ABBA9BB9860B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96D2-4B05-A0EB-ABBA9BB9860B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79B9-4DA6-9AEE-E385D6559B2A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79B9-4DA6-9AEE-E385D6559B2A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C-79B9-4DA6-9AEE-E385D6559B2A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multiLvlStrRef>
              <c:f>'Q8'!$G$5:$H$12</c:f>
              <c:multiLvlStrCache>
                <c:ptCount val="8"/>
                <c:lvl>
                  <c:pt idx="0">
                    <c:v>25–34</c:v>
                  </c:pt>
                  <c:pt idx="1">
                    <c:v>35–44</c:v>
                  </c:pt>
                  <c:pt idx="2">
                    <c:v>45–54</c:v>
                  </c:pt>
                  <c:pt idx="3">
                    <c:v>55–64</c:v>
                  </c:pt>
                  <c:pt idx="4">
                    <c:v>General</c:v>
                  </c:pt>
                  <c:pt idx="5">
                    <c:v>Physician</c:v>
                  </c:pt>
                  <c:pt idx="6">
                    <c:v>Nurse</c:v>
                  </c:pt>
                  <c:pt idx="7">
                    <c:v>Caregiver</c:v>
                  </c:pt>
                </c:lvl>
                <c:lvl>
                  <c:pt idx="0">
                    <c:v>Age (years)</c:v>
                  </c:pt>
                  <c:pt idx="4">
                    <c:v>Occupation</c:v>
                  </c:pt>
                </c:lvl>
              </c:multiLvlStrCache>
            </c:multiLvlStrRef>
          </c:cat>
          <c:val>
            <c:numRef>
              <c:f>'Q8'!$I$5:$I$12</c:f>
              <c:numCache>
                <c:formatCode>General</c:formatCode>
                <c:ptCount val="8"/>
                <c:pt idx="0">
                  <c:v>37.6</c:v>
                </c:pt>
                <c:pt idx="1">
                  <c:v>39.6</c:v>
                </c:pt>
                <c:pt idx="2">
                  <c:v>45.1</c:v>
                </c:pt>
                <c:pt idx="3">
                  <c:v>48.3</c:v>
                </c:pt>
                <c:pt idx="4">
                  <c:v>33.700000000000003</c:v>
                </c:pt>
                <c:pt idx="5">
                  <c:v>40.5</c:v>
                </c:pt>
                <c:pt idx="6">
                  <c:v>48.3</c:v>
                </c:pt>
                <c:pt idx="7">
                  <c:v>48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7BC-41BF-A43B-AAC81AF24E51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1023361600"/>
        <c:axId val="1023358688"/>
      </c:barChart>
      <c:catAx>
        <c:axId val="10233616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6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defRPr>
            </a:pPr>
            <a:endParaRPr lang="ja-JP"/>
          </a:p>
        </c:txPr>
        <c:crossAx val="1023358688"/>
        <c:crosses val="autoZero"/>
        <c:auto val="1"/>
        <c:lblAlgn val="ctr"/>
        <c:lblOffset val="100"/>
        <c:noMultiLvlLbl val="0"/>
      </c:catAx>
      <c:valAx>
        <c:axId val="1023358688"/>
        <c:scaling>
          <c:orientation val="minMax"/>
          <c:max val="60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6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400" dirty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ercentage</a:t>
                </a:r>
                <a:r>
                  <a:rPr lang="en-US" altLang="ja-JP" sz="1400" baseline="0" dirty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(</a:t>
                </a:r>
                <a:r>
                  <a:rPr lang="en-US" altLang="ja-JP" sz="1400" dirty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%)</a:t>
                </a:r>
                <a:endParaRPr lang="ja-JP" altLang="en-US" sz="1400" dirty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5.3249475890985321E-3"/>
              <c:y val="7.957435897435898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23361600"/>
        <c:crosses val="autoZero"/>
        <c:crossBetween val="between"/>
        <c:majorUnit val="3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Q8'!$I$4</c:f>
              <c:strCache>
                <c:ptCount val="1"/>
                <c:pt idx="0">
                  <c:v>残している</c:v>
                </c:pt>
              </c:strCache>
            </c:strRef>
          </c:tx>
          <c:spPr>
            <a:solidFill>
              <a:schemeClr val="accent5"/>
            </a:solidFill>
            <a:ln>
              <a:solidFill>
                <a:schemeClr val="accent5"/>
              </a:solidFill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09EE-4EE4-8996-61AC4DCF669B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AF2B-40BE-B98F-7ACB355DE182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09EE-4EE4-8996-61AC4DCF669B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09EE-4EE4-8996-61AC4DCF669B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6"/>
              </a:solidFill>
              <a:ln>
                <a:solidFill>
                  <a:schemeClr val="accent6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09EE-4EE4-8996-61AC4DCF669B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09EE-4EE4-8996-61AC4DCF669B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multiLvlStrRef>
              <c:f>'Q8'!$G$5:$H$12</c:f>
              <c:multiLvlStrCache>
                <c:ptCount val="8"/>
                <c:lvl>
                  <c:pt idx="0">
                    <c:v>25–34</c:v>
                  </c:pt>
                  <c:pt idx="1">
                    <c:v>35–44</c:v>
                  </c:pt>
                  <c:pt idx="2">
                    <c:v>45–54</c:v>
                  </c:pt>
                  <c:pt idx="3">
                    <c:v>55–64</c:v>
                  </c:pt>
                  <c:pt idx="4">
                    <c:v>General</c:v>
                  </c:pt>
                  <c:pt idx="5">
                    <c:v>Physician</c:v>
                  </c:pt>
                  <c:pt idx="6">
                    <c:v>Nurse</c:v>
                  </c:pt>
                  <c:pt idx="7">
                    <c:v>Caregiver</c:v>
                  </c:pt>
                </c:lvl>
                <c:lvl>
                  <c:pt idx="0">
                    <c:v>Age (years)</c:v>
                  </c:pt>
                  <c:pt idx="4">
                    <c:v>Occupation</c:v>
                  </c:pt>
                </c:lvl>
              </c:multiLvlStrCache>
            </c:multiLvlStrRef>
          </c:cat>
          <c:val>
            <c:numRef>
              <c:f>'Q8'!$I$5:$I$12</c:f>
              <c:numCache>
                <c:formatCode>General</c:formatCode>
                <c:ptCount val="8"/>
                <c:pt idx="0">
                  <c:v>10.199999999999999</c:v>
                </c:pt>
                <c:pt idx="1">
                  <c:v>9.7000000000000011</c:v>
                </c:pt>
                <c:pt idx="2">
                  <c:v>9.5</c:v>
                </c:pt>
                <c:pt idx="3">
                  <c:v>13.600000000000001</c:v>
                </c:pt>
                <c:pt idx="4">
                  <c:v>8.6999999999999993</c:v>
                </c:pt>
                <c:pt idx="5">
                  <c:v>10.4</c:v>
                </c:pt>
                <c:pt idx="6">
                  <c:v>8.6999999999999993</c:v>
                </c:pt>
                <c:pt idx="7" formatCode="0.0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7BC-41BF-A43B-AAC81AF24E51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1023361600"/>
        <c:axId val="1023358688"/>
      </c:barChart>
      <c:catAx>
        <c:axId val="10233616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1">
                <a:lumMod val="6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defRPr>
            </a:pPr>
            <a:endParaRPr lang="ja-JP"/>
          </a:p>
        </c:txPr>
        <c:crossAx val="1023358688"/>
        <c:crosses val="autoZero"/>
        <c:auto val="1"/>
        <c:lblAlgn val="ctr"/>
        <c:lblOffset val="100"/>
        <c:noMultiLvlLbl val="0"/>
      </c:catAx>
      <c:valAx>
        <c:axId val="1023358688"/>
        <c:scaling>
          <c:orientation val="minMax"/>
          <c:max val="60"/>
        </c:scaling>
        <c:delete val="0"/>
        <c:axPos val="l"/>
        <c:majorGridlines>
          <c:spPr>
            <a:ln w="9525" cap="flat" cmpd="sng" algn="ctr">
              <a:solidFill>
                <a:schemeClr val="bg1">
                  <a:lumMod val="6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400" dirty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ercentage</a:t>
                </a:r>
                <a:r>
                  <a:rPr lang="en-US" altLang="ja-JP" sz="1400" baseline="0" dirty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(</a:t>
                </a:r>
                <a:r>
                  <a:rPr lang="en-US" altLang="ja-JP" sz="1400" dirty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%)</a:t>
                </a:r>
                <a:endParaRPr lang="ja-JP" altLang="en-US" sz="1400" dirty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5.3249475890985321E-3"/>
              <c:y val="7.1637179487179486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23361600"/>
        <c:crosses val="autoZero"/>
        <c:crossBetween val="between"/>
        <c:majorUnit val="3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D6743112-40A1-CF24-BD64-39A17CB707C0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7825" cy="495300"/>
          </a:xfrm>
          <a:prstGeom prst="rect">
            <a:avLst/>
          </a:prstGeom>
        </p:spPr>
        <p:txBody>
          <a:bodyPr vert="horz" wrap="square" lIns="91367" tIns="45683" rIns="91367" bIns="45683" numCol="1" anchor="t" anchorCtr="0" compatLnSpc="1">
            <a:prstTxWarp prst="textNoShape">
              <a:avLst/>
            </a:prstTxWarp>
          </a:bodyPr>
          <a:lstStyle>
            <a:lvl1pPr>
              <a:defRPr sz="1200">
                <a:ea typeface="ＭＳ Ｐゴシック" panose="020B0600070205080204" pitchFamily="34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5C38DFC-E3CD-AB12-8965-A692C794EBCB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16350" y="0"/>
            <a:ext cx="2917825" cy="495300"/>
          </a:xfrm>
          <a:prstGeom prst="rect">
            <a:avLst/>
          </a:prstGeom>
        </p:spPr>
        <p:txBody>
          <a:bodyPr vert="horz" wrap="square" lIns="91367" tIns="45683" rIns="91367" bIns="45683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ea typeface="ＭＳ Ｐゴシック" panose="020B0600070205080204" pitchFamily="34" charset="-128"/>
              </a:defRPr>
            </a:lvl1pPr>
          </a:lstStyle>
          <a:p>
            <a:pPr>
              <a:defRPr/>
            </a:pPr>
            <a:fld id="{5B218D15-FD4B-48AC-9384-0B3FEA1CBE16}" type="datetimeFigureOut">
              <a:rPr lang="en-US" altLang="ja-JP"/>
              <a:pPr>
                <a:defRPr/>
              </a:pPr>
              <a:t>12/1/2023</a:t>
            </a:fld>
            <a:endParaRPr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5D12829-6066-B39B-1539-B4CE132C4A90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371013"/>
            <a:ext cx="2917825" cy="495300"/>
          </a:xfrm>
          <a:prstGeom prst="rect">
            <a:avLst/>
          </a:prstGeom>
        </p:spPr>
        <p:txBody>
          <a:bodyPr vert="horz" wrap="square" lIns="91367" tIns="45683" rIns="91367" bIns="45683" numCol="1" anchor="b" anchorCtr="0" compatLnSpc="1">
            <a:prstTxWarp prst="textNoShape">
              <a:avLst/>
            </a:prstTxWarp>
          </a:bodyPr>
          <a:lstStyle>
            <a:lvl1pPr>
              <a:defRPr sz="1200">
                <a:ea typeface="ＭＳ Ｐゴシック" panose="020B0600070205080204" pitchFamily="34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1DB5B7D-C7DB-DD80-81A4-531258DB75AB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16350" y="9371013"/>
            <a:ext cx="2917825" cy="495300"/>
          </a:xfrm>
          <a:prstGeom prst="rect">
            <a:avLst/>
          </a:prstGeom>
        </p:spPr>
        <p:txBody>
          <a:bodyPr vert="horz" wrap="square" lIns="91367" tIns="45683" rIns="91367" bIns="45683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27C05DDD-6A0D-4F46-A958-A21C2E104A1D}" type="slidenum">
              <a:rPr lang="en-US" altLang="ja-JP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8C8F1F74-06AE-0054-B811-2C4B25744FAD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2125"/>
          </a:xfrm>
          <a:prstGeom prst="rect">
            <a:avLst/>
          </a:prstGeom>
        </p:spPr>
        <p:txBody>
          <a:bodyPr vert="horz" wrap="square" lIns="90743" tIns="45373" rIns="90743" bIns="45373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ea typeface="ＭＳ Ｐゴシック" panose="020B0600070205080204" pitchFamily="34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072D79C-A9EB-A2B4-5341-024D98CCD569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2125"/>
          </a:xfrm>
          <a:prstGeom prst="rect">
            <a:avLst/>
          </a:prstGeom>
        </p:spPr>
        <p:txBody>
          <a:bodyPr vert="horz" wrap="square" lIns="90743" tIns="45373" rIns="90743" bIns="45373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ea typeface="ＭＳ Ｐゴシック" panose="020B0600070205080204" pitchFamily="34" charset="-128"/>
              </a:defRPr>
            </a:lvl1pPr>
          </a:lstStyle>
          <a:p>
            <a:pPr>
              <a:defRPr/>
            </a:pPr>
            <a:fld id="{7D7854C3-277B-4B24-9C77-8A0526121FE3}" type="datetimeFigureOut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4" name="スライド イメージ プレースホルダー 3">
            <a:extLst>
              <a:ext uri="{FF2B5EF4-FFF2-40B4-BE49-F238E27FC236}">
                <a16:creationId xmlns:a16="http://schemas.microsoft.com/office/drawing/2014/main" id="{B3C580DB-0DE3-46D8-4AEE-EF87AB1A40EF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79375" y="739775"/>
            <a:ext cx="657701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743" tIns="45373" rIns="90743" bIns="45373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ー 4">
            <a:extLst>
              <a:ext uri="{FF2B5EF4-FFF2-40B4-BE49-F238E27FC236}">
                <a16:creationId xmlns:a16="http://schemas.microsoft.com/office/drawing/2014/main" id="{11C1756D-A817-4879-86D3-A205D922775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74688" y="4684713"/>
            <a:ext cx="5386387" cy="4441825"/>
          </a:xfrm>
          <a:prstGeom prst="rect">
            <a:avLst/>
          </a:prstGeom>
        </p:spPr>
        <p:txBody>
          <a:bodyPr vert="horz" wrap="square" lIns="90743" tIns="45373" rIns="90743" bIns="45373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/>
              <a:t>マスター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C86D3E1-C543-91D7-3F6A-4E0DB4C52C21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9372600"/>
            <a:ext cx="2919413" cy="492125"/>
          </a:xfrm>
          <a:prstGeom prst="rect">
            <a:avLst/>
          </a:prstGeom>
        </p:spPr>
        <p:txBody>
          <a:bodyPr vert="horz" wrap="square" lIns="90743" tIns="45373" rIns="90743" bIns="45373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ea typeface="ＭＳ Ｐゴシック" panose="020B0600070205080204" pitchFamily="34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F2C9C07-BB1D-87CB-E42C-92923EBFFAF6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14763" y="9372600"/>
            <a:ext cx="2919412" cy="492125"/>
          </a:xfrm>
          <a:prstGeom prst="rect">
            <a:avLst/>
          </a:prstGeom>
        </p:spPr>
        <p:txBody>
          <a:bodyPr vert="horz" wrap="square" lIns="90743" tIns="45373" rIns="90743" bIns="45373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94690663-899B-4EFA-B643-223F29E83C7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スライド イメージ プレースホルダー 1">
            <a:extLst>
              <a:ext uri="{FF2B5EF4-FFF2-40B4-BE49-F238E27FC236}">
                <a16:creationId xmlns:a16="http://schemas.microsoft.com/office/drawing/2014/main" id="{5AC466E8-E27A-404E-AC61-500C86344ECF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1267" name="ノート プレースホルダー 2">
            <a:extLst>
              <a:ext uri="{FF2B5EF4-FFF2-40B4-BE49-F238E27FC236}">
                <a16:creationId xmlns:a16="http://schemas.microsoft.com/office/drawing/2014/main" id="{919112B1-7E94-485F-BBA9-30E81490B65A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ja-JP" altLang="en-US" dirty="0"/>
          </a:p>
        </p:txBody>
      </p:sp>
      <p:sp>
        <p:nvSpPr>
          <p:cNvPr id="11268" name="スライド番号プレースホルダー 3">
            <a:extLst>
              <a:ext uri="{FF2B5EF4-FFF2-40B4-BE49-F238E27FC236}">
                <a16:creationId xmlns:a16="http://schemas.microsoft.com/office/drawing/2014/main" id="{0E123DD0-3ABE-4BFE-A0B7-B6507F497722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7713" indent="-285750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52525" indent="-227013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14488" indent="-227013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74863" indent="-227013">
              <a:spcBef>
                <a:spcPct val="30000"/>
              </a:spcBef>
              <a:defRPr kumimoji="1"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32063" indent="-227013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89263" indent="-227013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46463" indent="-227013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903663" indent="-227013" eaLnBrk="0" fontAlgn="base" hangingPunct="0">
              <a:spcBef>
                <a:spcPct val="30000"/>
              </a:spcBef>
              <a:spcAft>
                <a:spcPct val="0"/>
              </a:spcAft>
              <a:defRPr kumimoji="1" sz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</a:pPr>
            <a:fld id="{D012B33D-DFFE-423B-87A4-5E2AAA055511}" type="slidenum">
              <a:rPr lang="ja-JP" altLang="en-US" smtClean="0"/>
              <a:pPr>
                <a:spcBef>
                  <a:spcPct val="0"/>
                </a:spcBef>
              </a:pPr>
              <a:t>1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211576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914400" y="2130433"/>
            <a:ext cx="103632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F84BB18-7E04-1245-5FFB-4B4DFACD7C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890C49-9CD2-492F-A985-3F30161D5999}" type="datetime1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2F44FC2-FFDC-4DCC-165A-E1D0039A2C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7D7781F-9289-1C0C-EE9B-55E4D1D8B5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E17C6B-6D8E-4255-AAA8-059CD8B659C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089281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FCD7BD-A5BE-B466-F8C0-639EABB927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084B85B-8250-4796-BFC9-B47DCB0A715D}" type="datetime1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1C9E757-CC78-FB94-8C7A-33447B66CE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9CCF139-7FE7-8721-6F70-4D107ADF6B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EFAAD9-634A-4702-A7D6-8876F7A87BB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15131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9575799" y="274646"/>
            <a:ext cx="2971801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60404" y="274646"/>
            <a:ext cx="8712201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65C398-C3F6-B701-D4F6-64F87E08E1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455061-5C5B-4435-9702-9F99DB62BE11}" type="datetime1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D8843CA-63B8-600E-B745-4242F89EAF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1F215C0-8DAB-552D-FE5C-35B04A761A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A81A39-73DF-4C96-98B8-B3F61E1DBD5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6874644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60AE6E8-2983-1AF4-E298-F1F0B0B6DA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2051FE-583A-4FC9-AD46-40E39C7483DA}" type="datetime1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8565CEF-D53E-2435-7196-EE6D5A1A2D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1BCACFB-C71B-A967-7C3F-F7D7DE0D7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57CEAB-F491-4213-B105-83CDCA349BA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505364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963084" y="4406908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5A75AC5-776A-67A8-C03C-AF6BE07163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4D1A1-0192-4FEB-AE2C-2B3172D39E6D}" type="datetime1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F47E598-C96F-BF45-5B87-7FF987C2EC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74E177F-8F3E-2D74-AF61-1A0D6E74C7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507F47-4B18-445B-9D49-C53EEF766D9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61035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60401" y="1600206"/>
            <a:ext cx="58420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705601" y="1600206"/>
            <a:ext cx="58420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3">
            <a:extLst>
              <a:ext uri="{FF2B5EF4-FFF2-40B4-BE49-F238E27FC236}">
                <a16:creationId xmlns:a16="http://schemas.microsoft.com/office/drawing/2014/main" id="{2D4D1C20-B189-B3AF-0585-4B210B89A1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9BC02D-8464-4C57-8BC5-B16CDF6AC0AE}" type="datetime1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6" name="フッター プレースホルダー 4">
            <a:extLst>
              <a:ext uri="{FF2B5EF4-FFF2-40B4-BE49-F238E27FC236}">
                <a16:creationId xmlns:a16="http://schemas.microsoft.com/office/drawing/2014/main" id="{CE4286D6-6C62-647E-13F4-5C47054EDF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>
            <a:extLst>
              <a:ext uri="{FF2B5EF4-FFF2-40B4-BE49-F238E27FC236}">
                <a16:creationId xmlns:a16="http://schemas.microsoft.com/office/drawing/2014/main" id="{1A7CE18C-B4AE-9E13-F004-8F65942D7B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4A6B05-D29A-48D0-A583-338C4EA6BBC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3988912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93371" y="1535113"/>
            <a:ext cx="5389034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93371" y="2174875"/>
            <a:ext cx="5389034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3">
            <a:extLst>
              <a:ext uri="{FF2B5EF4-FFF2-40B4-BE49-F238E27FC236}">
                <a16:creationId xmlns:a16="http://schemas.microsoft.com/office/drawing/2014/main" id="{0A7827E1-770C-1CA1-B74C-85927501FF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6A2F0B-D8F7-48D8-A2DB-6740B2E4A662}" type="datetime1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8" name="フッター プレースホルダー 4">
            <a:extLst>
              <a:ext uri="{FF2B5EF4-FFF2-40B4-BE49-F238E27FC236}">
                <a16:creationId xmlns:a16="http://schemas.microsoft.com/office/drawing/2014/main" id="{B3A53CC7-CCF1-880B-2629-B9A6D37071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5">
            <a:extLst>
              <a:ext uri="{FF2B5EF4-FFF2-40B4-BE49-F238E27FC236}">
                <a16:creationId xmlns:a16="http://schemas.microsoft.com/office/drawing/2014/main" id="{C6C4FB0E-8372-0CFC-93F9-061AFA16E7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98D256-F712-4452-8BA1-D45D0F72A6B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162015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3">
            <a:extLst>
              <a:ext uri="{FF2B5EF4-FFF2-40B4-BE49-F238E27FC236}">
                <a16:creationId xmlns:a16="http://schemas.microsoft.com/office/drawing/2014/main" id="{943FB045-9D13-B4CE-1A2D-ED17CC15DD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2E0FD7-C44C-43E9-A42D-885E636FA749}" type="datetime1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4" name="フッター プレースホルダー 4">
            <a:extLst>
              <a:ext uri="{FF2B5EF4-FFF2-40B4-BE49-F238E27FC236}">
                <a16:creationId xmlns:a16="http://schemas.microsoft.com/office/drawing/2014/main" id="{94F4777C-4552-7DDE-8F8A-E162026FD9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5">
            <a:extLst>
              <a:ext uri="{FF2B5EF4-FFF2-40B4-BE49-F238E27FC236}">
                <a16:creationId xmlns:a16="http://schemas.microsoft.com/office/drawing/2014/main" id="{483128B8-144B-40E6-DB36-6087C4BF53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C1D279-3FEE-46AB-A930-7DBF16D37AB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291345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3">
            <a:extLst>
              <a:ext uri="{FF2B5EF4-FFF2-40B4-BE49-F238E27FC236}">
                <a16:creationId xmlns:a16="http://schemas.microsoft.com/office/drawing/2014/main" id="{24C0FC43-4054-E4E0-05F5-BF1B3A1033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43340E2-3349-4361-ACEF-50E35F3FE58A}" type="datetime1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3" name="フッター プレースホルダー 4">
            <a:extLst>
              <a:ext uri="{FF2B5EF4-FFF2-40B4-BE49-F238E27FC236}">
                <a16:creationId xmlns:a16="http://schemas.microsoft.com/office/drawing/2014/main" id="{9A8F5AC5-0928-96EE-2B6C-46091A860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5">
            <a:extLst>
              <a:ext uri="{FF2B5EF4-FFF2-40B4-BE49-F238E27FC236}">
                <a16:creationId xmlns:a16="http://schemas.microsoft.com/office/drawing/2014/main" id="{C88A6335-8AF8-1C97-70AD-788A6721C5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AFCF7D-412F-437B-925E-A1CD0480E2D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5709220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09600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766736" y="273058"/>
            <a:ext cx="6815666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09600" y="1435103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>
            <a:extLst>
              <a:ext uri="{FF2B5EF4-FFF2-40B4-BE49-F238E27FC236}">
                <a16:creationId xmlns:a16="http://schemas.microsoft.com/office/drawing/2014/main" id="{6453978D-18D0-D730-9B68-296E523B97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BB6721-6685-4476-9F7E-208E2A668E43}" type="datetime1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6" name="フッター プレースホルダー 4">
            <a:extLst>
              <a:ext uri="{FF2B5EF4-FFF2-40B4-BE49-F238E27FC236}">
                <a16:creationId xmlns:a16="http://schemas.microsoft.com/office/drawing/2014/main" id="{C98CB824-E953-FBA8-31C4-0F09290647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>
            <a:extLst>
              <a:ext uri="{FF2B5EF4-FFF2-40B4-BE49-F238E27FC236}">
                <a16:creationId xmlns:a16="http://schemas.microsoft.com/office/drawing/2014/main" id="{2294B84F-8FD8-62DA-5F3F-1A8EE8F325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2D41FE-542E-47C4-AC38-AA58B7D1025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738777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>
            <a:extLst>
              <a:ext uri="{FF2B5EF4-FFF2-40B4-BE49-F238E27FC236}">
                <a16:creationId xmlns:a16="http://schemas.microsoft.com/office/drawing/2014/main" id="{FEACDEE3-87E0-3FE9-E88F-B781D2583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4FF98C-2D41-414C-9913-C9C13F8822F2}" type="datetime1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6" name="フッター プレースホルダー 4">
            <a:extLst>
              <a:ext uri="{FF2B5EF4-FFF2-40B4-BE49-F238E27FC236}">
                <a16:creationId xmlns:a16="http://schemas.microsoft.com/office/drawing/2014/main" id="{2854F57A-1F4A-0129-1C04-D8E3DB44FF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>
            <a:extLst>
              <a:ext uri="{FF2B5EF4-FFF2-40B4-BE49-F238E27FC236}">
                <a16:creationId xmlns:a16="http://schemas.microsoft.com/office/drawing/2014/main" id="{B57CD52B-9D65-8B62-9A2B-FF75599242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785C45-55C0-4E43-9347-3E66DB8930D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2677343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>
            <a:extLst>
              <a:ext uri="{FF2B5EF4-FFF2-40B4-BE49-F238E27FC236}">
                <a16:creationId xmlns:a16="http://schemas.microsoft.com/office/drawing/2014/main" id="{A045A50A-5E74-3AF6-F2C4-14102A4B3627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609600" y="274638"/>
            <a:ext cx="109728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タイトルの書式設定</a:t>
            </a:r>
          </a:p>
        </p:txBody>
      </p:sp>
      <p:sp>
        <p:nvSpPr>
          <p:cNvPr id="1027" name="テキスト プレースホルダー 2">
            <a:extLst>
              <a:ext uri="{FF2B5EF4-FFF2-40B4-BE49-F238E27FC236}">
                <a16:creationId xmlns:a16="http://schemas.microsoft.com/office/drawing/2014/main" id="{0184E445-7936-28DF-9C46-73EE40556260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609600" y="1600200"/>
            <a:ext cx="109728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DF1291E-4E52-D485-8474-D39C3160A2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09600" y="6356350"/>
            <a:ext cx="28448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solidFill>
                  <a:srgbClr val="898989"/>
                </a:solidFill>
                <a:ea typeface="ＭＳ Ｐゴシック" panose="020B0600070205080204" pitchFamily="34" charset="-128"/>
              </a:defRPr>
            </a:lvl1pPr>
          </a:lstStyle>
          <a:p>
            <a:pPr>
              <a:defRPr/>
            </a:pPr>
            <a:fld id="{9BDBBC19-C59E-469B-AA6F-D5E5D1DFE98C}" type="datetime1">
              <a:rPr lang="ja-JP" altLang="en-US"/>
              <a:pPr>
                <a:defRPr/>
              </a:pPr>
              <a:t>2023/12/1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1F4AB11-476F-9758-A0A6-8CE6326E302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165600" y="6356350"/>
            <a:ext cx="38608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 eaLnBrk="1" hangingPunct="1">
              <a:defRPr sz="1200">
                <a:solidFill>
                  <a:srgbClr val="898989"/>
                </a:solidFill>
                <a:ea typeface="ＭＳ Ｐゴシック" panose="020B0600070205080204" pitchFamily="34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EBE4AF4-DCBC-B77F-B934-51EA8786DE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737600" y="6356350"/>
            <a:ext cx="28448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C01CCA4D-91EF-4C09-B914-11D11F9125F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DF4F94F8-DD42-4891-BB4E-987A0C0FB0C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62333452"/>
              </p:ext>
            </p:extLst>
          </p:nvPr>
        </p:nvGraphicFramePr>
        <p:xfrm>
          <a:off x="592392" y="1159489"/>
          <a:ext cx="9540000" cy="23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EFB47462-003D-401D-9C8D-3F6659CDA28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52520344"/>
              </p:ext>
            </p:extLst>
          </p:nvPr>
        </p:nvGraphicFramePr>
        <p:xfrm>
          <a:off x="592390" y="4011770"/>
          <a:ext cx="9540000" cy="23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07EDF89-0775-4342-8768-575316769B23}"/>
              </a:ext>
            </a:extLst>
          </p:cNvPr>
          <p:cNvSpPr txBox="1"/>
          <p:nvPr/>
        </p:nvSpPr>
        <p:spPr>
          <a:xfrm>
            <a:off x="4284580" y="3220863"/>
            <a:ext cx="11620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006</a:t>
            </a:r>
            <a:endParaRPr lang="ja-JP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A303F0C-92D8-4C6C-B105-132DDEAA0613}"/>
              </a:ext>
            </a:extLst>
          </p:cNvPr>
          <p:cNvSpPr txBox="1"/>
          <p:nvPr/>
        </p:nvSpPr>
        <p:spPr>
          <a:xfrm>
            <a:off x="8897122" y="3220863"/>
            <a:ext cx="9373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&lt; 0.001</a:t>
            </a:r>
            <a:endParaRPr lang="ja-JP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F2B34FC-C5CB-4D5D-98D2-6BEB6ED8358C}"/>
              </a:ext>
            </a:extLst>
          </p:cNvPr>
          <p:cNvSpPr txBox="1"/>
          <p:nvPr/>
        </p:nvSpPr>
        <p:spPr>
          <a:xfrm>
            <a:off x="4151231" y="6062911"/>
            <a:ext cx="1295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= 0.189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AB89E4B-63C4-4194-BCA8-E343D89C210A}"/>
              </a:ext>
            </a:extLst>
          </p:cNvPr>
          <p:cNvSpPr txBox="1"/>
          <p:nvPr/>
        </p:nvSpPr>
        <p:spPr>
          <a:xfrm>
            <a:off x="8411389" y="6058450"/>
            <a:ext cx="14231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4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= 0.009</a:t>
            </a:r>
            <a:endParaRPr lang="ja-JP" altLang="en-US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7333368-C541-8CBD-CBAE-6D73125B25F4}"/>
              </a:ext>
            </a:extLst>
          </p:cNvPr>
          <p:cNvSpPr txBox="1"/>
          <p:nvPr/>
        </p:nvSpPr>
        <p:spPr>
          <a:xfrm>
            <a:off x="1608173" y="1255995"/>
            <a:ext cx="5378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solidFill>
                  <a:srgbClr val="FF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endParaRPr kumimoji="1" lang="ja-JP" altLang="en-US" dirty="0">
              <a:solidFill>
                <a:srgbClr val="FF33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831F3A61-0756-1663-CD1D-80F22CEE4CF7}"/>
              </a:ext>
            </a:extLst>
          </p:cNvPr>
          <p:cNvSpPr txBox="1"/>
          <p:nvPr/>
        </p:nvSpPr>
        <p:spPr>
          <a:xfrm>
            <a:off x="4845801" y="982917"/>
            <a:ext cx="53788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>
                <a:solidFill>
                  <a:srgbClr val="FF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3200" dirty="0">
              <a:solidFill>
                <a:srgbClr val="FF33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28D89E28-CFF2-36F1-3B55-94F6D320668B}"/>
              </a:ext>
            </a:extLst>
          </p:cNvPr>
          <p:cNvSpPr txBox="1"/>
          <p:nvPr/>
        </p:nvSpPr>
        <p:spPr>
          <a:xfrm>
            <a:off x="5926221" y="1299343"/>
            <a:ext cx="5378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solidFill>
                  <a:srgbClr val="FF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endParaRPr kumimoji="1" lang="ja-JP" altLang="en-US" dirty="0">
              <a:solidFill>
                <a:srgbClr val="FF33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9619399-DDEC-54E9-FD44-208185489E39}"/>
              </a:ext>
            </a:extLst>
          </p:cNvPr>
          <p:cNvSpPr txBox="1"/>
          <p:nvPr/>
        </p:nvSpPr>
        <p:spPr>
          <a:xfrm>
            <a:off x="9172240" y="958292"/>
            <a:ext cx="53788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>
                <a:solidFill>
                  <a:srgbClr val="FF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3200" dirty="0">
              <a:solidFill>
                <a:srgbClr val="FF33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D6E30944-3505-BA75-13CD-40AD4C4DEE1A}"/>
              </a:ext>
            </a:extLst>
          </p:cNvPr>
          <p:cNvSpPr txBox="1"/>
          <p:nvPr/>
        </p:nvSpPr>
        <p:spPr>
          <a:xfrm>
            <a:off x="8093301" y="958293"/>
            <a:ext cx="53788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>
                <a:solidFill>
                  <a:srgbClr val="FF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3200" dirty="0">
              <a:solidFill>
                <a:srgbClr val="FF33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3C81FD28-6735-AB8D-61EF-6FF3FE0FDA4D}"/>
              </a:ext>
            </a:extLst>
          </p:cNvPr>
          <p:cNvSpPr txBox="1"/>
          <p:nvPr/>
        </p:nvSpPr>
        <p:spPr>
          <a:xfrm>
            <a:off x="9163773" y="4552387"/>
            <a:ext cx="53788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>
                <a:solidFill>
                  <a:srgbClr val="FF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3200" dirty="0">
              <a:solidFill>
                <a:srgbClr val="FF33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C5B72979-2C0D-45FB-A4A3-2D03636F912A}"/>
              </a:ext>
            </a:extLst>
          </p:cNvPr>
          <p:cNvSpPr txBox="1"/>
          <p:nvPr/>
        </p:nvSpPr>
        <p:spPr>
          <a:xfrm>
            <a:off x="5943154" y="4759288"/>
            <a:ext cx="5378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solidFill>
                  <a:srgbClr val="FF33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endParaRPr kumimoji="1" lang="ja-JP" altLang="en-US" dirty="0">
              <a:solidFill>
                <a:srgbClr val="FF33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8107360-6FE8-1441-1D67-180473103666}"/>
              </a:ext>
            </a:extLst>
          </p:cNvPr>
          <p:cNvSpPr txBox="1"/>
          <p:nvPr/>
        </p:nvSpPr>
        <p:spPr>
          <a:xfrm>
            <a:off x="582893" y="3634514"/>
            <a:ext cx="679268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85744" indent="-285744">
              <a:buFont typeface="Wingdings" panose="05000000000000000000" pitchFamily="2" charset="2"/>
              <a:buChar char="n"/>
              <a:defRPr/>
            </a:pPr>
            <a:r>
              <a:rPr lang="en-US" altLang="ja-JP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ocumented</a:t>
            </a:r>
            <a:endParaRPr lang="ja-JP" altLang="en-US" dirty="0"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B1B77C4-5FF6-E8DD-3A64-6716B6BF8B8A}"/>
              </a:ext>
            </a:extLst>
          </p:cNvPr>
          <p:cNvSpPr txBox="1"/>
          <p:nvPr/>
        </p:nvSpPr>
        <p:spPr>
          <a:xfrm>
            <a:off x="582897" y="789931"/>
            <a:ext cx="653018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85744" indent="-285744">
              <a:buFont typeface="Wingdings" panose="05000000000000000000" pitchFamily="2" charset="2"/>
              <a:buChar char="n"/>
              <a:defRPr/>
            </a:pPr>
            <a:r>
              <a:rPr lang="en-US" altLang="ja-JP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iscussed</a:t>
            </a:r>
            <a:endParaRPr lang="ja-JP" altLang="en-US" dirty="0"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1E324F6-0E12-2000-A269-BC122DD7B102}"/>
              </a:ext>
            </a:extLst>
          </p:cNvPr>
          <p:cNvSpPr txBox="1"/>
          <p:nvPr/>
        </p:nvSpPr>
        <p:spPr>
          <a:xfrm>
            <a:off x="261257" y="234447"/>
            <a:ext cx="1185091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S1. Respondents with experience discussing and documenting personal future treatment and care preferences</a:t>
            </a:r>
            <a:endParaRPr lang="ja-JP" altLang="en-US" dirty="0"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AB6322E-D1A3-016C-8DF1-B7306BD114B3}"/>
              </a:ext>
            </a:extLst>
          </p:cNvPr>
          <p:cNvSpPr txBox="1"/>
          <p:nvPr/>
        </p:nvSpPr>
        <p:spPr>
          <a:xfrm>
            <a:off x="592390" y="6501319"/>
            <a:ext cx="1112789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sz="14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*Statistically higher for adjusted residual (&gt;1.96), †Statistically lower for adjusted residual (&lt;-1.96)</a:t>
            </a:r>
          </a:p>
        </p:txBody>
      </p:sp>
    </p:spTree>
    <p:extLst>
      <p:ext uri="{BB962C8B-B14F-4D97-AF65-F5344CB8AC3E}">
        <p14:creationId xmlns:p14="http://schemas.microsoft.com/office/powerpoint/2010/main" val="7052617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00</TotalTime>
  <Words>59</Words>
  <Application>Microsoft Office PowerPoint</Application>
  <PresentationFormat>ワイド画面</PresentationFormat>
  <Paragraphs>18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Wingdings</vt:lpstr>
      <vt:lpstr>Office ​​テーマ</vt:lpstr>
      <vt:lpstr>PowerPoint プレゼンテーション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KANISHI</dc:creator>
  <cp:lastModifiedBy>中西康裕</cp:lastModifiedBy>
  <cp:revision>1102</cp:revision>
  <cp:lastPrinted>2022-06-03T09:43:16Z</cp:lastPrinted>
  <dcterms:created xsi:type="dcterms:W3CDTF">2014-06-20T06:24:21Z</dcterms:created>
  <dcterms:modified xsi:type="dcterms:W3CDTF">2023-12-01T09:11:09Z</dcterms:modified>
</cp:coreProperties>
</file>